
<file path=[Content_Types].xml><?xml version="1.0" encoding="utf-8"?>
<Types xmlns="http://schemas.openxmlformats.org/package/2006/content-types">
  <Default Extension="jpeg" ContentType="image/jpeg"/>
  <Default Extension="jpg" ContentType="image/pn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6" r:id="rId3"/>
    <p:sldId id="258" r:id="rId4"/>
    <p:sldId id="259" r:id="rId5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7" autoAdjust="0"/>
    <p:restoredTop sz="94660"/>
  </p:normalViewPr>
  <p:slideViewPr>
    <p:cSldViewPr snapToGrid="0">
      <p:cViewPr varScale="1">
        <p:scale>
          <a:sx n="85" d="100"/>
          <a:sy n="85" d="100"/>
        </p:scale>
        <p:origin x="590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46F3478-D13E-4DB7-0E62-295C1796104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01D01EE2-84E3-AB0E-3BEB-075CDFCF1DC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20B7A4D-FC93-E3A6-75B9-76A4D7ADE6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02749A-CE94-485F-B28F-267B9473694A}" type="datetimeFigureOut">
              <a:rPr lang="zh-CN" altLang="en-US" smtClean="0"/>
              <a:t>2023/12/1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C210631-9483-73B3-5603-81A1289C24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A79B031-29A6-DB96-4FBD-A4438BFE32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0C7C7C-1057-4BD1-BFB9-985EBD2B636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308630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C315E5E-10D4-F700-ED28-CD4BA7DB086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550D5475-325F-6E6C-1C6E-9D3A5B6940F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FC76869-AE12-50A7-A598-1EA716923B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02749A-CE94-485F-B28F-267B9473694A}" type="datetimeFigureOut">
              <a:rPr lang="zh-CN" altLang="en-US" smtClean="0"/>
              <a:t>2023/12/1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E273D6D-0837-FFCD-54A1-B299EB29C1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7960C6C-3630-F6AD-D29F-580B56011F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0C7C7C-1057-4BD1-BFB9-985EBD2B636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048183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14F9C404-5237-75EA-F2C5-D21EE96DE87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7A3D7765-EC50-468B-9395-ADB6A1A943E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88ABE08-C05D-93CC-AE62-FEB5789D9E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02749A-CE94-485F-B28F-267B9473694A}" type="datetimeFigureOut">
              <a:rPr lang="zh-CN" altLang="en-US" smtClean="0"/>
              <a:t>2023/12/1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6BC411B-B286-E490-1104-310EB4AB92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7BFF543-13C3-15E1-8B31-B62D1BD919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0C7C7C-1057-4BD1-BFB9-985EBD2B636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066473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B956DC1-F9C5-A9D5-2932-33353617A60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D4949F88-0999-A453-0809-0465837879A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8368B91-41B5-956F-2CC9-DFCA204A02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02749A-CE94-485F-B28F-267B9473694A}" type="datetimeFigureOut">
              <a:rPr lang="zh-CN" altLang="en-US" smtClean="0"/>
              <a:t>2023/12/1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1BFAF41-176A-D6F1-A9D4-9186411A60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2BC50B7-1ABE-9C24-178F-5F69DD8995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0C7C7C-1057-4BD1-BFB9-985EBD2B636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042916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7535A22-5D70-4EBE-10E6-E5AB6DA991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906EE670-7BF3-4F03-0F51-84C921AF1F3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F3C5C8C-989C-BA7F-E39B-9B6C8C0878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02749A-CE94-485F-B28F-267B9473694A}" type="datetimeFigureOut">
              <a:rPr lang="zh-CN" altLang="en-US" smtClean="0"/>
              <a:t>2023/12/1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07B5E22-E7B9-1A25-0E57-E446486D2E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16B20BE-ACE0-A2A8-C1D9-65A6815E8C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0C7C7C-1057-4BD1-BFB9-985EBD2B636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992966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C164553-93C9-7132-C2CF-B6DFD210E0B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2C91FA83-F869-854B-90F0-F64E2A4C977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0ABAE954-8046-8505-06A0-89AACBBAA1A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3080617C-4E1C-2C53-CF7C-E693276B21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02749A-CE94-485F-B28F-267B9473694A}" type="datetimeFigureOut">
              <a:rPr lang="zh-CN" altLang="en-US" smtClean="0"/>
              <a:t>2023/12/1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FD02B173-8F06-C6EC-F5B9-761EA24354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7BAED316-D4A6-EB75-9EF8-5928B6F17D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0C7C7C-1057-4BD1-BFB9-985EBD2B636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916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BAA2EF2-7A79-9616-E3A9-54423138DB4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5519C6F3-E53F-DE97-F893-0CAC2F234F5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D0A72B2C-44F3-A7D6-AD49-EBC5F6E9A36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B26AF0C0-115C-22A3-51EF-A68004307AE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6714D68D-44F7-8F29-C1A6-8BA3A7548B5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0B4A49BF-2768-BD65-3283-61DB977833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02749A-CE94-485F-B28F-267B9473694A}" type="datetimeFigureOut">
              <a:rPr lang="zh-CN" altLang="en-US" smtClean="0"/>
              <a:t>2023/12/14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B41A3C32-3914-B986-9FD2-00A0EA8B50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01491E0B-F823-0F66-18E8-157EF07D9E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0C7C7C-1057-4BD1-BFB9-985EBD2B636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177339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97BB76B-D5F4-E1E1-6191-7C6415D18D0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49FCCD78-C74B-712B-D7EA-D6E13DB3A6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02749A-CE94-485F-B28F-267B9473694A}" type="datetimeFigureOut">
              <a:rPr lang="zh-CN" altLang="en-US" smtClean="0"/>
              <a:t>2023/12/14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E8454C7A-DB6B-6096-8C1F-CA357785F7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552F9141-5DE0-E9E8-5905-2104EAA53E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0C7C7C-1057-4BD1-BFB9-985EBD2B636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836178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B83432B8-1690-CE22-24EB-DFDF8BE26A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02749A-CE94-485F-B28F-267B9473694A}" type="datetimeFigureOut">
              <a:rPr lang="zh-CN" altLang="en-US" smtClean="0"/>
              <a:t>2023/12/14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B516BC37-6A2D-039A-84DD-88BD46EEC0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180D7E7C-6ADF-F688-DBCE-F4DC4D41E6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0C7C7C-1057-4BD1-BFB9-985EBD2B636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636406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E9B6131-8632-2B8D-7417-77B703C8592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3D1669D9-0EA4-4104-F3CE-EE31A0A1BBC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A64BFA20-AD92-6768-B0E6-4BC10BFCF37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F31E0283-B4F2-4EF7-6E36-0C2AAA2574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02749A-CE94-485F-B28F-267B9473694A}" type="datetimeFigureOut">
              <a:rPr lang="zh-CN" altLang="en-US" smtClean="0"/>
              <a:t>2023/12/1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D03351D1-CBE9-E5FA-26E6-85E45274BC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6B2B677E-9C39-650B-BFD9-F9B69E842A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0C7C7C-1057-4BD1-BFB9-985EBD2B636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581289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45D5322-A54F-D03C-74A6-5D6EBB43C49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9B0C5EF6-3F4F-76CD-8AB2-127B020D8F0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/>
              <a:t>单击图标添加图片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B44FB20E-CAB0-6612-2997-22A8BE9D711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574481D7-6EE1-0A8E-7F29-1BCE64AEA7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02749A-CE94-485F-B28F-267B9473694A}" type="datetimeFigureOut">
              <a:rPr lang="zh-CN" altLang="en-US" smtClean="0"/>
              <a:t>2023/12/1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34786B8F-0AE9-E615-4A48-9D4D9E74F9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DE089304-AF74-6468-040B-4BABB45849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0C7C7C-1057-4BD1-BFB9-985EBD2B636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03636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259C8A24-4205-00F0-AB3A-AB160F4CB9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7BA4C78E-1680-11B1-4467-54313538B41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8ACD5C2-524E-2E6F-0EE5-4E00769B9AA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02749A-CE94-485F-B28F-267B9473694A}" type="datetimeFigureOut">
              <a:rPr lang="zh-CN" altLang="en-US" smtClean="0"/>
              <a:t>2023/12/1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BCCD128-BF9C-F533-3E5E-F5250DC1BA2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2443423-9536-F181-334E-B24D6355C3A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0C7C7C-1057-4BD1-BFB9-985EBD2B636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452419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18" Type="http://schemas.openxmlformats.org/officeDocument/2006/relationships/image" Target="../media/image17.jp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" Type="http://schemas.openxmlformats.org/officeDocument/2006/relationships/image" Target="../media/image1.jpg"/><Relationship Id="rId16" Type="http://schemas.openxmlformats.org/officeDocument/2006/relationships/image" Target="../media/image15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10" Type="http://schemas.openxmlformats.org/officeDocument/2006/relationships/image" Target="../media/image9.png"/><Relationship Id="rId19" Type="http://schemas.openxmlformats.org/officeDocument/2006/relationships/image" Target="../media/image18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5.png"/><Relationship Id="rId13" Type="http://schemas.openxmlformats.org/officeDocument/2006/relationships/image" Target="../media/image30.png"/><Relationship Id="rId18" Type="http://schemas.openxmlformats.org/officeDocument/2006/relationships/image" Target="../media/image35.png"/><Relationship Id="rId3" Type="http://schemas.openxmlformats.org/officeDocument/2006/relationships/image" Target="../media/image20.png"/><Relationship Id="rId7" Type="http://schemas.openxmlformats.org/officeDocument/2006/relationships/image" Target="../media/image24.png"/><Relationship Id="rId12" Type="http://schemas.openxmlformats.org/officeDocument/2006/relationships/image" Target="../media/image29.png"/><Relationship Id="rId17" Type="http://schemas.openxmlformats.org/officeDocument/2006/relationships/image" Target="../media/image34.png"/><Relationship Id="rId2" Type="http://schemas.openxmlformats.org/officeDocument/2006/relationships/image" Target="../media/image19.png"/><Relationship Id="rId16" Type="http://schemas.openxmlformats.org/officeDocument/2006/relationships/image" Target="../media/image3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3.png"/><Relationship Id="rId11" Type="http://schemas.openxmlformats.org/officeDocument/2006/relationships/image" Target="../media/image28.png"/><Relationship Id="rId5" Type="http://schemas.openxmlformats.org/officeDocument/2006/relationships/image" Target="../media/image22.png"/><Relationship Id="rId15" Type="http://schemas.openxmlformats.org/officeDocument/2006/relationships/image" Target="../media/image32.png"/><Relationship Id="rId10" Type="http://schemas.openxmlformats.org/officeDocument/2006/relationships/image" Target="../media/image27.png"/><Relationship Id="rId19" Type="http://schemas.openxmlformats.org/officeDocument/2006/relationships/image" Target="../media/image36.png"/><Relationship Id="rId4" Type="http://schemas.openxmlformats.org/officeDocument/2006/relationships/image" Target="../media/image21.png"/><Relationship Id="rId9" Type="http://schemas.openxmlformats.org/officeDocument/2006/relationships/image" Target="../media/image26.png"/><Relationship Id="rId14" Type="http://schemas.openxmlformats.org/officeDocument/2006/relationships/image" Target="../media/image3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60C4942-F7DA-50F8-971E-04CF136ECC5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333240" y="2539365"/>
            <a:ext cx="10515600" cy="1325563"/>
          </a:xfrm>
        </p:spPr>
        <p:txBody>
          <a:bodyPr/>
          <a:lstStyle/>
          <a:p>
            <a:r>
              <a:rPr lang="en-US" altLang="zh-CN" dirty="0"/>
              <a:t>Panc-1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90055968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C461E775-F7ED-2CD8-AC16-4C404795DC0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61684" y="5802514"/>
            <a:ext cx="2269596" cy="862588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99DAE6D3-35B9-D8E1-E146-69845351B24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57870" y="4772675"/>
            <a:ext cx="2259650" cy="867837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B576A51E-B5FC-E8EC-8F01-6A18368EDBB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55741" y="5802514"/>
            <a:ext cx="2664922" cy="852266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E1EDF7B6-BA7E-609F-AC69-230FD720A63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55741" y="3749605"/>
            <a:ext cx="2237199" cy="852266"/>
          </a:xfrm>
          <a:prstGeom prst="rect">
            <a:avLst/>
          </a:prstGeom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44422BF1-425A-BF1F-41A3-D8397C2D24E9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55741" y="2548962"/>
            <a:ext cx="2371410" cy="969336"/>
          </a:xfrm>
          <a:prstGeom prst="rect">
            <a:avLst/>
          </a:prstGeom>
        </p:spPr>
      </p:pic>
      <p:pic>
        <p:nvPicPr>
          <p:cNvPr id="15" name="图片 14">
            <a:extLst>
              <a:ext uri="{FF2B5EF4-FFF2-40B4-BE49-F238E27FC236}">
                <a16:creationId xmlns:a16="http://schemas.microsoft.com/office/drawing/2014/main" id="{A9F7D71E-B537-3ABB-E8D3-C2EA8D844001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755741" y="1419209"/>
            <a:ext cx="2261779" cy="932187"/>
          </a:xfrm>
          <a:prstGeom prst="rect">
            <a:avLst/>
          </a:prstGeom>
        </p:spPr>
      </p:pic>
      <p:pic>
        <p:nvPicPr>
          <p:cNvPr id="17" name="图片 16">
            <a:extLst>
              <a:ext uri="{FF2B5EF4-FFF2-40B4-BE49-F238E27FC236}">
                <a16:creationId xmlns:a16="http://schemas.microsoft.com/office/drawing/2014/main" id="{5ADB1E8A-A1A4-F376-18F2-6C9068A06B3D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733290" y="164832"/>
            <a:ext cx="2259650" cy="1106449"/>
          </a:xfrm>
          <a:prstGeom prst="rect">
            <a:avLst/>
          </a:prstGeom>
        </p:spPr>
      </p:pic>
      <p:pic>
        <p:nvPicPr>
          <p:cNvPr id="19" name="图片 18">
            <a:extLst>
              <a:ext uri="{FF2B5EF4-FFF2-40B4-BE49-F238E27FC236}">
                <a16:creationId xmlns:a16="http://schemas.microsoft.com/office/drawing/2014/main" id="{469E3602-3484-495E-073F-63C7F9EF945F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7275195" y="5816034"/>
            <a:ext cx="2072005" cy="855828"/>
          </a:xfrm>
          <a:prstGeom prst="rect">
            <a:avLst/>
          </a:prstGeom>
        </p:spPr>
      </p:pic>
      <p:pic>
        <p:nvPicPr>
          <p:cNvPr id="21" name="图片 20">
            <a:extLst>
              <a:ext uri="{FF2B5EF4-FFF2-40B4-BE49-F238E27FC236}">
                <a16:creationId xmlns:a16="http://schemas.microsoft.com/office/drawing/2014/main" id="{D0D4F717-4A26-BCD8-3709-4FB963F0C3CC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4053787" y="4861400"/>
            <a:ext cx="2485390" cy="690386"/>
          </a:xfrm>
          <a:prstGeom prst="rect">
            <a:avLst/>
          </a:prstGeom>
        </p:spPr>
      </p:pic>
      <p:pic>
        <p:nvPicPr>
          <p:cNvPr id="25" name="图片 24">
            <a:extLst>
              <a:ext uri="{FF2B5EF4-FFF2-40B4-BE49-F238E27FC236}">
                <a16:creationId xmlns:a16="http://schemas.microsoft.com/office/drawing/2014/main" id="{19FB7A6B-C474-D65A-FEF6-7E45DC160C31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7275195" y="4724813"/>
            <a:ext cx="2028825" cy="781050"/>
          </a:xfrm>
          <a:prstGeom prst="rect">
            <a:avLst/>
          </a:prstGeom>
        </p:spPr>
      </p:pic>
      <p:pic>
        <p:nvPicPr>
          <p:cNvPr id="27" name="图片 26">
            <a:extLst>
              <a:ext uri="{FF2B5EF4-FFF2-40B4-BE49-F238E27FC236}">
                <a16:creationId xmlns:a16="http://schemas.microsoft.com/office/drawing/2014/main" id="{AA7D7EAC-FB8A-FE4C-95C7-2C5509FE0F2B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3957322" y="3540130"/>
            <a:ext cx="2485390" cy="1144890"/>
          </a:xfrm>
          <a:prstGeom prst="rect">
            <a:avLst/>
          </a:prstGeom>
        </p:spPr>
      </p:pic>
      <p:pic>
        <p:nvPicPr>
          <p:cNvPr id="29" name="图片 28">
            <a:extLst>
              <a:ext uri="{FF2B5EF4-FFF2-40B4-BE49-F238E27FC236}">
                <a16:creationId xmlns:a16="http://schemas.microsoft.com/office/drawing/2014/main" id="{A84EB5CA-A4F1-2D5E-7584-F03CF4B74113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7047863" y="3596035"/>
            <a:ext cx="2352041" cy="951139"/>
          </a:xfrm>
          <a:prstGeom prst="rect">
            <a:avLst/>
          </a:prstGeom>
        </p:spPr>
      </p:pic>
      <p:pic>
        <p:nvPicPr>
          <p:cNvPr id="31" name="图片 30">
            <a:extLst>
              <a:ext uri="{FF2B5EF4-FFF2-40B4-BE49-F238E27FC236}">
                <a16:creationId xmlns:a16="http://schemas.microsoft.com/office/drawing/2014/main" id="{6501CA86-2EAF-C210-FFEF-6DEB1C34C34B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4076700" y="2423240"/>
            <a:ext cx="2019300" cy="1028700"/>
          </a:xfrm>
          <a:prstGeom prst="rect">
            <a:avLst/>
          </a:prstGeom>
        </p:spPr>
      </p:pic>
      <p:pic>
        <p:nvPicPr>
          <p:cNvPr id="33" name="图片 32">
            <a:extLst>
              <a:ext uri="{FF2B5EF4-FFF2-40B4-BE49-F238E27FC236}">
                <a16:creationId xmlns:a16="http://schemas.microsoft.com/office/drawing/2014/main" id="{AC52DC27-9FCA-3C1F-27A7-01F3BCE27BC4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7045549" y="2548962"/>
            <a:ext cx="2200275" cy="923925"/>
          </a:xfrm>
          <a:prstGeom prst="rect">
            <a:avLst/>
          </a:prstGeom>
        </p:spPr>
      </p:pic>
      <p:pic>
        <p:nvPicPr>
          <p:cNvPr id="35" name="图片 34">
            <a:extLst>
              <a:ext uri="{FF2B5EF4-FFF2-40B4-BE49-F238E27FC236}">
                <a16:creationId xmlns:a16="http://schemas.microsoft.com/office/drawing/2014/main" id="{C968E0C8-7A14-1C58-22B0-1E5007BFCD5F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3834221" y="1468417"/>
            <a:ext cx="2261779" cy="954823"/>
          </a:xfrm>
          <a:prstGeom prst="rect">
            <a:avLst/>
          </a:prstGeom>
        </p:spPr>
      </p:pic>
      <p:pic>
        <p:nvPicPr>
          <p:cNvPr id="37" name="图片 36">
            <a:extLst>
              <a:ext uri="{FF2B5EF4-FFF2-40B4-BE49-F238E27FC236}">
                <a16:creationId xmlns:a16="http://schemas.microsoft.com/office/drawing/2014/main" id="{3CDD8A9C-B1A8-4506-EBD6-FC57F54BC4A8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6845300" y="1363369"/>
            <a:ext cx="2352041" cy="1168577"/>
          </a:xfrm>
          <a:prstGeom prst="rect">
            <a:avLst/>
          </a:prstGeom>
        </p:spPr>
      </p:pic>
      <p:pic>
        <p:nvPicPr>
          <p:cNvPr id="39" name="图片 38">
            <a:extLst>
              <a:ext uri="{FF2B5EF4-FFF2-40B4-BE49-F238E27FC236}">
                <a16:creationId xmlns:a16="http://schemas.microsoft.com/office/drawing/2014/main" id="{DDC93DDD-586D-C3C2-3376-A73DF1511E34}"/>
              </a:ext>
            </a:extLst>
          </p:cNvPr>
          <p:cNvPicPr>
            <a:picLocks noChangeAspect="1"/>
          </p:cNvPicPr>
          <p:nvPr/>
        </p:nvPicPr>
        <p:blipFill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57322" y="284082"/>
            <a:ext cx="2089059" cy="933607"/>
          </a:xfrm>
          <a:prstGeom prst="rect">
            <a:avLst/>
          </a:prstGeom>
        </p:spPr>
      </p:pic>
      <p:pic>
        <p:nvPicPr>
          <p:cNvPr id="41" name="图片 40">
            <a:extLst>
              <a:ext uri="{FF2B5EF4-FFF2-40B4-BE49-F238E27FC236}">
                <a16:creationId xmlns:a16="http://schemas.microsoft.com/office/drawing/2014/main" id="{88A080F6-4D9F-1E7E-745D-6AE53595499A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6812280" y="255374"/>
            <a:ext cx="2143125" cy="1019175"/>
          </a:xfrm>
          <a:prstGeom prst="rect">
            <a:avLst/>
          </a:prstGeom>
        </p:spPr>
      </p:pic>
      <p:sp>
        <p:nvSpPr>
          <p:cNvPr id="42" name="文本框 41">
            <a:extLst>
              <a:ext uri="{FF2B5EF4-FFF2-40B4-BE49-F238E27FC236}">
                <a16:creationId xmlns:a16="http://schemas.microsoft.com/office/drawing/2014/main" id="{BD9FFD77-4A91-3D37-FAA5-2E64BB1068B2}"/>
              </a:ext>
            </a:extLst>
          </p:cNvPr>
          <p:cNvSpPr txBox="1"/>
          <p:nvPr/>
        </p:nvSpPr>
        <p:spPr>
          <a:xfrm>
            <a:off x="9855200" y="629920"/>
            <a:ext cx="13817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E-cadherin</a:t>
            </a:r>
            <a:endParaRPr lang="zh-CN" altLang="en-US" dirty="0"/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5EA2D754-13B6-049D-EF02-E72A363D0A9B}"/>
              </a:ext>
            </a:extLst>
          </p:cNvPr>
          <p:cNvSpPr txBox="1"/>
          <p:nvPr/>
        </p:nvSpPr>
        <p:spPr>
          <a:xfrm>
            <a:off x="9763760" y="1761162"/>
            <a:ext cx="13817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N-cadherin</a:t>
            </a:r>
            <a:endParaRPr lang="zh-CN" altLang="en-US" dirty="0"/>
          </a:p>
        </p:txBody>
      </p:sp>
      <p:sp>
        <p:nvSpPr>
          <p:cNvPr id="44" name="文本框 43">
            <a:extLst>
              <a:ext uri="{FF2B5EF4-FFF2-40B4-BE49-F238E27FC236}">
                <a16:creationId xmlns:a16="http://schemas.microsoft.com/office/drawing/2014/main" id="{62FEB3FB-5CAD-93B2-0B9A-74F97F33D80A}"/>
              </a:ext>
            </a:extLst>
          </p:cNvPr>
          <p:cNvSpPr txBox="1"/>
          <p:nvPr/>
        </p:nvSpPr>
        <p:spPr>
          <a:xfrm>
            <a:off x="9855200" y="2848964"/>
            <a:ext cx="13817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Vimentin</a:t>
            </a:r>
            <a:endParaRPr lang="zh-CN" altLang="en-US" dirty="0"/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id="{F2CD19A6-83BB-A549-1A9B-FCEE612E96DD}"/>
              </a:ext>
            </a:extLst>
          </p:cNvPr>
          <p:cNvSpPr txBox="1"/>
          <p:nvPr/>
        </p:nvSpPr>
        <p:spPr>
          <a:xfrm>
            <a:off x="10105972" y="4837261"/>
            <a:ext cx="13817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err="1"/>
              <a:t>akt</a:t>
            </a:r>
            <a:endParaRPr lang="zh-CN" altLang="en-US" dirty="0"/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id="{F74273E7-005C-4ED1-A722-AEA4BD039428}"/>
              </a:ext>
            </a:extLst>
          </p:cNvPr>
          <p:cNvSpPr txBox="1"/>
          <p:nvPr/>
        </p:nvSpPr>
        <p:spPr>
          <a:xfrm>
            <a:off x="10054499" y="3855182"/>
            <a:ext cx="13817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p-</a:t>
            </a:r>
            <a:r>
              <a:rPr lang="en-US" altLang="zh-CN" dirty="0" err="1"/>
              <a:t>akt</a:t>
            </a:r>
            <a:endParaRPr lang="zh-CN" altLang="en-US" dirty="0"/>
          </a:p>
        </p:txBody>
      </p:sp>
      <p:sp>
        <p:nvSpPr>
          <p:cNvPr id="47" name="文本框 46">
            <a:extLst>
              <a:ext uri="{FF2B5EF4-FFF2-40B4-BE49-F238E27FC236}">
                <a16:creationId xmlns:a16="http://schemas.microsoft.com/office/drawing/2014/main" id="{21876BD0-2159-2448-407D-C1716B0FD4F7}"/>
              </a:ext>
            </a:extLst>
          </p:cNvPr>
          <p:cNvSpPr txBox="1"/>
          <p:nvPr/>
        </p:nvSpPr>
        <p:spPr>
          <a:xfrm>
            <a:off x="9916160" y="5992642"/>
            <a:ext cx="13817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β-actin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88291337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DE9562F-F7DC-D425-D02B-7278E79D482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5082540" y="2103437"/>
            <a:ext cx="2026920" cy="1325563"/>
          </a:xfrm>
        </p:spPr>
        <p:txBody>
          <a:bodyPr/>
          <a:lstStyle/>
          <a:p>
            <a:r>
              <a:rPr lang="en-US" altLang="zh-CN" dirty="0"/>
              <a:t>BxPC-3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17732783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1E1C21F2-EE33-780B-EDED-41E5E506799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180897" y="5759849"/>
            <a:ext cx="2828925" cy="800100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9B6B8C4F-45FC-2E2A-C29D-3BB5FE01C12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18783" y="5658458"/>
            <a:ext cx="2828926" cy="814731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AD4C3D73-BCF1-A666-9275-551E53D9155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621087" y="5658458"/>
            <a:ext cx="3084513" cy="901491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EA0DC914-576A-28BC-FCF8-CB7E7D4ED2C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18783" y="4563777"/>
            <a:ext cx="2713672" cy="952166"/>
          </a:xfrm>
          <a:prstGeom prst="rect">
            <a:avLst/>
          </a:prstGeom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50E84CD2-FA09-7899-F3C4-91881F315FC1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755072" y="4760958"/>
            <a:ext cx="2713673" cy="754985"/>
          </a:xfrm>
          <a:prstGeom prst="rect">
            <a:avLst/>
          </a:prstGeom>
        </p:spPr>
      </p:pic>
      <p:pic>
        <p:nvPicPr>
          <p:cNvPr id="15" name="图片 14">
            <a:extLst>
              <a:ext uri="{FF2B5EF4-FFF2-40B4-BE49-F238E27FC236}">
                <a16:creationId xmlns:a16="http://schemas.microsoft.com/office/drawing/2014/main" id="{921BE383-42AE-775B-4268-12C2A97D1380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7180897" y="4760958"/>
            <a:ext cx="2680967" cy="754985"/>
          </a:xfrm>
          <a:prstGeom prst="rect">
            <a:avLst/>
          </a:prstGeom>
        </p:spPr>
      </p:pic>
      <p:pic>
        <p:nvPicPr>
          <p:cNvPr id="17" name="图片 16">
            <a:extLst>
              <a:ext uri="{FF2B5EF4-FFF2-40B4-BE49-F238E27FC236}">
                <a16:creationId xmlns:a16="http://schemas.microsoft.com/office/drawing/2014/main" id="{B34B77E0-F6B9-A19C-C0F2-B7B56777A0B6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18783" y="3444240"/>
            <a:ext cx="3028950" cy="809625"/>
          </a:xfrm>
          <a:prstGeom prst="rect">
            <a:avLst/>
          </a:prstGeom>
        </p:spPr>
      </p:pic>
      <p:pic>
        <p:nvPicPr>
          <p:cNvPr id="19" name="图片 18">
            <a:extLst>
              <a:ext uri="{FF2B5EF4-FFF2-40B4-BE49-F238E27FC236}">
                <a16:creationId xmlns:a16="http://schemas.microsoft.com/office/drawing/2014/main" id="{59FD4713-1366-FE7A-E65C-588520682275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739514" y="3486785"/>
            <a:ext cx="2847658" cy="869198"/>
          </a:xfrm>
          <a:prstGeom prst="rect">
            <a:avLst/>
          </a:prstGeom>
        </p:spPr>
      </p:pic>
      <p:pic>
        <p:nvPicPr>
          <p:cNvPr id="21" name="图片 20">
            <a:extLst>
              <a:ext uri="{FF2B5EF4-FFF2-40B4-BE49-F238E27FC236}">
                <a16:creationId xmlns:a16="http://schemas.microsoft.com/office/drawing/2014/main" id="{4398B452-BC0B-91DF-0E7D-65D64EEDAEFD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7088184" y="3513513"/>
            <a:ext cx="2743200" cy="962025"/>
          </a:xfrm>
          <a:prstGeom prst="rect">
            <a:avLst/>
          </a:prstGeom>
        </p:spPr>
      </p:pic>
      <p:pic>
        <p:nvPicPr>
          <p:cNvPr id="23" name="图片 22">
            <a:extLst>
              <a:ext uri="{FF2B5EF4-FFF2-40B4-BE49-F238E27FC236}">
                <a16:creationId xmlns:a16="http://schemas.microsoft.com/office/drawing/2014/main" id="{A79F1039-1093-AE81-59B4-FC2804EDFD91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3621087" y="2514036"/>
            <a:ext cx="3251046" cy="901491"/>
          </a:xfrm>
          <a:prstGeom prst="rect">
            <a:avLst/>
          </a:prstGeom>
        </p:spPr>
      </p:pic>
      <p:pic>
        <p:nvPicPr>
          <p:cNvPr id="25" name="图片 24">
            <a:extLst>
              <a:ext uri="{FF2B5EF4-FFF2-40B4-BE49-F238E27FC236}">
                <a16:creationId xmlns:a16="http://schemas.microsoft.com/office/drawing/2014/main" id="{24B459BD-316A-FD51-EA71-9B113A89F126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352107" y="2304253"/>
            <a:ext cx="3084513" cy="985031"/>
          </a:xfrm>
          <a:prstGeom prst="rect">
            <a:avLst/>
          </a:prstGeom>
        </p:spPr>
      </p:pic>
      <p:pic>
        <p:nvPicPr>
          <p:cNvPr id="27" name="图片 26">
            <a:extLst>
              <a:ext uri="{FF2B5EF4-FFF2-40B4-BE49-F238E27FC236}">
                <a16:creationId xmlns:a16="http://schemas.microsoft.com/office/drawing/2014/main" id="{05F1D44C-CF0C-C4C6-1CE6-9D66D605178F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7037304" y="2469127"/>
            <a:ext cx="2968152" cy="922433"/>
          </a:xfrm>
          <a:prstGeom prst="rect">
            <a:avLst/>
          </a:prstGeom>
        </p:spPr>
      </p:pic>
      <p:pic>
        <p:nvPicPr>
          <p:cNvPr id="29" name="图片 28">
            <a:extLst>
              <a:ext uri="{FF2B5EF4-FFF2-40B4-BE49-F238E27FC236}">
                <a16:creationId xmlns:a16="http://schemas.microsoft.com/office/drawing/2014/main" id="{CCDF2D7B-636E-475D-F5A3-C05E760E752A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408070" y="1359779"/>
            <a:ext cx="3213017" cy="747683"/>
          </a:xfrm>
          <a:prstGeom prst="rect">
            <a:avLst/>
          </a:prstGeom>
        </p:spPr>
      </p:pic>
      <p:pic>
        <p:nvPicPr>
          <p:cNvPr id="31" name="图片 30">
            <a:extLst>
              <a:ext uri="{FF2B5EF4-FFF2-40B4-BE49-F238E27FC236}">
                <a16:creationId xmlns:a16="http://schemas.microsoft.com/office/drawing/2014/main" id="{F55068AC-CFD8-BA42-A3C8-5CA9D8857326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7254738" y="1524590"/>
            <a:ext cx="3211192" cy="676415"/>
          </a:xfrm>
          <a:prstGeom prst="rect">
            <a:avLst/>
          </a:prstGeom>
        </p:spPr>
      </p:pic>
      <p:pic>
        <p:nvPicPr>
          <p:cNvPr id="33" name="图片 32">
            <a:extLst>
              <a:ext uri="{FF2B5EF4-FFF2-40B4-BE49-F238E27FC236}">
                <a16:creationId xmlns:a16="http://schemas.microsoft.com/office/drawing/2014/main" id="{B9B288CF-9124-0F54-91E3-0603F69A7902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3838521" y="1488957"/>
            <a:ext cx="3198783" cy="747683"/>
          </a:xfrm>
          <a:prstGeom prst="rect">
            <a:avLst/>
          </a:prstGeom>
        </p:spPr>
      </p:pic>
      <p:pic>
        <p:nvPicPr>
          <p:cNvPr id="35" name="图片 34">
            <a:extLst>
              <a:ext uri="{FF2B5EF4-FFF2-40B4-BE49-F238E27FC236}">
                <a16:creationId xmlns:a16="http://schemas.microsoft.com/office/drawing/2014/main" id="{E3680A7F-896A-AB68-E105-E3AB36D86447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418783" y="457811"/>
            <a:ext cx="3028950" cy="796746"/>
          </a:xfrm>
          <a:prstGeom prst="rect">
            <a:avLst/>
          </a:prstGeom>
        </p:spPr>
      </p:pic>
      <p:pic>
        <p:nvPicPr>
          <p:cNvPr id="37" name="图片 36">
            <a:extLst>
              <a:ext uri="{FF2B5EF4-FFF2-40B4-BE49-F238E27FC236}">
                <a16:creationId xmlns:a16="http://schemas.microsoft.com/office/drawing/2014/main" id="{97E3480F-D836-EB9F-1D13-E67902B7247E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3831853" y="544635"/>
            <a:ext cx="2968152" cy="709922"/>
          </a:xfrm>
          <a:prstGeom prst="rect">
            <a:avLst/>
          </a:prstGeom>
        </p:spPr>
      </p:pic>
      <p:pic>
        <p:nvPicPr>
          <p:cNvPr id="39" name="图片 38">
            <a:extLst>
              <a:ext uri="{FF2B5EF4-FFF2-40B4-BE49-F238E27FC236}">
                <a16:creationId xmlns:a16="http://schemas.microsoft.com/office/drawing/2014/main" id="{7751E590-9C8F-ACFF-33BD-1E58A4920665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7280118" y="459761"/>
            <a:ext cx="2463322" cy="882296"/>
          </a:xfrm>
          <a:prstGeom prst="rect">
            <a:avLst/>
          </a:prstGeom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3F979E28-FCB0-48C0-84B3-DC3C28B6F386}"/>
              </a:ext>
            </a:extLst>
          </p:cNvPr>
          <p:cNvSpPr txBox="1"/>
          <p:nvPr/>
        </p:nvSpPr>
        <p:spPr>
          <a:xfrm>
            <a:off x="10537985" y="720994"/>
            <a:ext cx="138176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Vimentin</a:t>
            </a:r>
            <a:endParaRPr lang="zh-CN" altLang="en-US" dirty="0"/>
          </a:p>
          <a:p>
            <a:endParaRPr lang="zh-CN" altLang="en-US" dirty="0"/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98FDF725-F09F-AE34-CAD8-F3C5093EBF43}"/>
              </a:ext>
            </a:extLst>
          </p:cNvPr>
          <p:cNvSpPr txBox="1"/>
          <p:nvPr/>
        </p:nvSpPr>
        <p:spPr>
          <a:xfrm>
            <a:off x="10446545" y="1852236"/>
            <a:ext cx="13817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N-cadherin</a:t>
            </a:r>
            <a:endParaRPr lang="zh-CN" altLang="en-US" dirty="0"/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72E3DF28-5B6A-7E1E-9E15-F4FC3B90CC9C}"/>
              </a:ext>
            </a:extLst>
          </p:cNvPr>
          <p:cNvSpPr txBox="1"/>
          <p:nvPr/>
        </p:nvSpPr>
        <p:spPr>
          <a:xfrm>
            <a:off x="10537985" y="2940038"/>
            <a:ext cx="13817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E-cadherin</a:t>
            </a:r>
            <a:endParaRPr lang="zh-CN" altLang="en-US" dirty="0"/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7A3EC5D5-4834-41E9-83EB-A4F918383BFE}"/>
              </a:ext>
            </a:extLst>
          </p:cNvPr>
          <p:cNvSpPr txBox="1"/>
          <p:nvPr/>
        </p:nvSpPr>
        <p:spPr>
          <a:xfrm>
            <a:off x="10788757" y="4928335"/>
            <a:ext cx="13817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err="1"/>
              <a:t>akt</a:t>
            </a:r>
            <a:endParaRPr lang="zh-CN" altLang="en-US" dirty="0"/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5ED7E3D7-1E9B-A2B8-3DED-E516653A35B4}"/>
              </a:ext>
            </a:extLst>
          </p:cNvPr>
          <p:cNvSpPr txBox="1"/>
          <p:nvPr/>
        </p:nvSpPr>
        <p:spPr>
          <a:xfrm>
            <a:off x="10737284" y="3946256"/>
            <a:ext cx="13817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p-</a:t>
            </a:r>
            <a:r>
              <a:rPr lang="en-US" altLang="zh-CN" dirty="0" err="1"/>
              <a:t>akt</a:t>
            </a:r>
            <a:endParaRPr lang="zh-CN" altLang="en-US" dirty="0"/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6E7D3038-2BC4-92D8-9D25-6A0966E7EC28}"/>
              </a:ext>
            </a:extLst>
          </p:cNvPr>
          <p:cNvSpPr txBox="1"/>
          <p:nvPr/>
        </p:nvSpPr>
        <p:spPr>
          <a:xfrm>
            <a:off x="10598945" y="6083716"/>
            <a:ext cx="13817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β-actin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2772994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蛋白条带</Template>
  <TotalTime>48</TotalTime>
  <Words>14</Words>
  <Application>Microsoft Office PowerPoint</Application>
  <PresentationFormat>宽屏</PresentationFormat>
  <Paragraphs>14</Paragraphs>
  <Slides>4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8" baseType="lpstr">
      <vt:lpstr>等线</vt:lpstr>
      <vt:lpstr>等线 Light</vt:lpstr>
      <vt:lpstr>Arial</vt:lpstr>
      <vt:lpstr>Office 主题​​</vt:lpstr>
      <vt:lpstr>Panc-1</vt:lpstr>
      <vt:lpstr>PowerPoint 演示文稿</vt:lpstr>
      <vt:lpstr>BxPC-3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anc-1</dc:title>
  <dc:creator>SunBei</dc:creator>
  <cp:lastModifiedBy>聪 何</cp:lastModifiedBy>
  <cp:revision>4</cp:revision>
  <dcterms:created xsi:type="dcterms:W3CDTF">2023-07-25T08:23:20Z</dcterms:created>
  <dcterms:modified xsi:type="dcterms:W3CDTF">2023-12-14T12:09:45Z</dcterms:modified>
</cp:coreProperties>
</file>